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56" d="100"/>
          <a:sy n="56" d="100"/>
        </p:scale>
        <p:origin x="96" y="12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7AB9D9-9F3C-414D-A84B-3C5A0BC5EF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42848F-FD62-404E-90DF-259B9ADFAF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611864-8354-456A-A0BB-4410C2C2A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ADAEFE-E686-45E8-A809-3F7CF10CC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D60407-5D59-43BF-9110-473C5958A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6449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5ADC2-3FEA-4B0F-A948-6A560AE2AC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74032A-88B3-4AEB-BC26-3D35D72ABB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6A2A72-53C1-47EA-A500-4E6A2E5DC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61CCF2-05AE-45ED-9729-712863791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8DD1B1-75B8-4B9D-9900-924AFC567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27876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D81D90-9535-4DD2-81FE-BE58A5CEFA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B4626C-484D-42FF-AA98-445F69AB96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362BFE-A6D4-4800-9897-17DC5F448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95FF3-12C2-482E-B898-2F451D9CD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0DC1E0-D160-4E34-921A-822A7FD8E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48944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983440-7F2B-41F3-85D5-F9C6521281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8E2477-6D98-4814-A7B0-925AEA9CC4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66C67E-8D31-43A6-A5FA-7BA924D7C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6D123C-9367-4676-9EA1-746C76F34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CEE72-FECF-4C29-A510-01C022490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48791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F2892A-3740-4F7E-92F1-ACC5C5013A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178069-8077-4796-8B8E-DF9E951F2E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DFE762-91C5-41B6-8ACE-3888F6D5CC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24BC0D-9B55-4870-8D17-268C1800F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359A62-E6EB-43B1-B251-4ADB080AE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45733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CC6DAB-C6BE-4971-B817-D6C7A870BB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83DB52-EEE2-41DB-9407-C7B89D372D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4C93DD-0112-4E36-AB60-0296DAF154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B8A493-52A1-4EA1-9DFE-8F19E5491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848761-7F50-48C9-8E7D-5DBF27398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A3BA03-40F4-4401-B503-53CB5CAF6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7907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0CA51D-D1AE-488F-A449-CAE1F9B64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75A5D9-5D88-4C87-A035-DA53157C70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664E67-E3CB-4EEC-AFF1-0B7E610435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8F7A4EF-3468-488F-BC37-C53DAE2715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AA83D82-A7B9-4F29-AF99-EC8BA9DA61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95EFF1-9AFA-476B-9750-FE431B0E7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244ADA-870F-4977-95B7-EB80C8E1E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A3F5F5-E2C9-42CD-A115-E4B144F27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09357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53A3A8-314D-4660-996C-BA865C52AC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3CE0C9-A58F-4C4C-AFFD-E396B110F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745BD36-7534-4D46-8589-2E7A8DE8A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D97BA86-6160-432E-B853-16B8C9732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34270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EE2D31-0840-48EE-B08D-7917C028F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0F72EA-0191-4E11-91FB-1C30CCC22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1FCDF7-8DE3-41DC-ADD7-F1D98DDD5E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78008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D5F830-F34A-4065-9205-CB820A96F5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2DF457-8704-4938-B51D-04FA7771A5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23106D-685E-43CE-A77A-49CB9CA27A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BB94B4-560A-4BB1-91BD-9B3F124D9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A192B0-56B9-4631-A4C2-4A7DBF03D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8C3505-5B32-4966-835C-CCEA938D0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68612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DB78ED-9AD2-4DAA-9DA4-715924F881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4DFFE2-8E5D-4378-9FB8-780E4DB0C4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527AD3-7387-4CB2-979B-CC4DA8F042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BE3AD0-35C7-48E1-9ADC-79F423A96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EF6190-8410-4825-849F-E0A9E3284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316AA3-020D-43F9-A4C1-C0A4AB675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60875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BF9A4A-46DB-49AC-8302-9A3B05C1B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844BD8-487A-4B38-91E3-1438F951D9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49227B-6AFF-4AEE-9B6C-798E0C5427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E35C5-9918-46F9-8F5B-690B979ED117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E02FFA-5A1F-4C68-AAE1-6AD039A334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8916CC-3D51-4851-8382-F9C8DCE300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E8DA5-BFF4-4998-8BB7-7D583470231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71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FE2182E-AD2E-4AB4-B5A6-43276232A6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9180" y="1876044"/>
            <a:ext cx="2453640" cy="310591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609B9C7-DC9E-422B-AB9A-6D8D82EB63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39351" y="1876044"/>
            <a:ext cx="2729829" cy="316016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6801FFF-59E5-4A11-9DBD-C33CC50E23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22820" y="1871939"/>
            <a:ext cx="2729829" cy="316426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F397612-C545-49E3-9E64-86F53F75B9BE}"/>
              </a:ext>
            </a:extLst>
          </p:cNvPr>
          <p:cNvSpPr txBox="1"/>
          <p:nvPr/>
        </p:nvSpPr>
        <p:spPr>
          <a:xfrm>
            <a:off x="2139351" y="5036207"/>
            <a:ext cx="791329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 Figure 2: 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oung’s Modulus, yield strength and modulus of resilience of scaffolds with different </a:t>
            </a:r>
            <a:r>
              <a:rPr lang="en-CA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L/nHA concentrations ranging from 0% (wt.) nHA to 30% (wt.) nHA. An nHA composition of 10% was found to provide a significant (p&lt;0.05) increase to the mechanical properties after Kruskal-Wallis statistical analysis. Overall, the addition of nHA at various compositions was found to improve the mechanical properties of the scaffolds tested.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1640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nda</dc:creator>
  <cp:lastModifiedBy>Amanda</cp:lastModifiedBy>
  <cp:revision>6</cp:revision>
  <dcterms:created xsi:type="dcterms:W3CDTF">2020-12-12T21:24:56Z</dcterms:created>
  <dcterms:modified xsi:type="dcterms:W3CDTF">2021-01-21T03:09:27Z</dcterms:modified>
</cp:coreProperties>
</file>